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84" d="100"/>
          <a:sy n="84" d="100"/>
        </p:scale>
        <p:origin x="1296" y="-4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C3A946-1178-46F4-AB0C-75D19122335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8CEFC2-9D94-4B70-AA7C-611E757635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7468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63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262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541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5921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271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4159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2651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222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087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7579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4472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577817-24F7-4387-BEC7-D4584E48A8A2}" type="datetimeFigureOut">
              <a:rPr lang="en-GB" smtClean="0"/>
              <a:t>28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BC223-1E22-4A38-95CE-FC735639581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9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47" t="14358" r="71591" b="79817"/>
          <a:stretch/>
        </p:blipFill>
        <p:spPr>
          <a:xfrm>
            <a:off x="1038261" y="977725"/>
            <a:ext cx="1798533" cy="4677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2" name="TextBox 81"/>
          <p:cNvSpPr txBox="1"/>
          <p:nvPr/>
        </p:nvSpPr>
        <p:spPr>
          <a:xfrm>
            <a:off x="714717" y="757049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8000000">
            <a:off x="1141655" y="723356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8000000">
            <a:off x="1440953" y="60789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613899" y="127200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09196" y="92544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92"/>
          <p:cNvCxnSpPr/>
          <p:nvPr/>
        </p:nvCxnSpPr>
        <p:spPr>
          <a:xfrm>
            <a:off x="914065" y="1044501"/>
            <a:ext cx="10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914065" y="1404541"/>
            <a:ext cx="10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6" name="Picture 10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086" t="17642" r="71484" b="75491"/>
          <a:stretch/>
        </p:blipFill>
        <p:spPr>
          <a:xfrm>
            <a:off x="1128256" y="3944666"/>
            <a:ext cx="1603227" cy="5845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7" name="TextBox 106"/>
          <p:cNvSpPr txBox="1"/>
          <p:nvPr/>
        </p:nvSpPr>
        <p:spPr>
          <a:xfrm>
            <a:off x="692915" y="4129258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Straight Connector 109"/>
          <p:cNvCxnSpPr/>
          <p:nvPr/>
        </p:nvCxnSpPr>
        <p:spPr>
          <a:xfrm>
            <a:off x="985952" y="4247556"/>
            <a:ext cx="10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810223" y="3744258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1" name="Picture 130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303" t="25318" r="34513" b="69131"/>
          <a:stretch/>
        </p:blipFill>
        <p:spPr>
          <a:xfrm>
            <a:off x="1088131" y="2407565"/>
            <a:ext cx="1656184" cy="464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2" name="TextBox 131"/>
          <p:cNvSpPr txBox="1"/>
          <p:nvPr/>
        </p:nvSpPr>
        <p:spPr>
          <a:xfrm>
            <a:off x="729689" y="256255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134"/>
          <p:cNvCxnSpPr/>
          <p:nvPr/>
        </p:nvCxnSpPr>
        <p:spPr>
          <a:xfrm>
            <a:off x="964399" y="2683728"/>
            <a:ext cx="108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786086" y="2215357"/>
            <a:ext cx="3257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 rot="18000000">
            <a:off x="1781619" y="59891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8000000">
            <a:off x="1924579" y="583219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 rot="18000000">
            <a:off x="2149180" y="596671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 rot="18000000">
            <a:off x="2251087" y="554075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aA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840231" y="1104961"/>
            <a:ext cx="540671" cy="230832"/>
            <a:chOff x="4320533" y="1175528"/>
            <a:chExt cx="540671" cy="230832"/>
          </a:xfrm>
        </p:grpSpPr>
        <p:sp>
          <p:nvSpPr>
            <p:cNvPr id="145" name="TextBox 144"/>
            <p:cNvSpPr txBox="1"/>
            <p:nvPr/>
          </p:nvSpPr>
          <p:spPr>
            <a:xfrm>
              <a:off x="4367548" y="1175528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aA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146" name="Straight Arrow Connector 145"/>
            <p:cNvCxnSpPr/>
            <p:nvPr/>
          </p:nvCxnSpPr>
          <p:spPr>
            <a:xfrm flipH="1">
              <a:off x="4320533" y="1301404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</p:grpSp>
      <p:sp>
        <p:nvSpPr>
          <p:cNvPr id="147" name="TextBox 146"/>
          <p:cNvSpPr txBox="1"/>
          <p:nvPr/>
        </p:nvSpPr>
        <p:spPr>
          <a:xfrm rot="18000000">
            <a:off x="1141654" y="2133368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 rot="18000000">
            <a:off x="1444959" y="2017902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B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 rot="18000000">
            <a:off x="1785625" y="2008931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B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 rot="18000000">
            <a:off x="1928586" y="1993231"/>
            <a:ext cx="615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B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 rot="18000000">
            <a:off x="2153186" y="2006683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B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 rot="18000000">
            <a:off x="2255093" y="1964087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B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" name="Group 152"/>
          <p:cNvGrpSpPr/>
          <p:nvPr/>
        </p:nvGrpSpPr>
        <p:grpSpPr>
          <a:xfrm>
            <a:off x="2757153" y="2493706"/>
            <a:ext cx="540671" cy="230832"/>
            <a:chOff x="4320533" y="1175528"/>
            <a:chExt cx="540671" cy="230832"/>
          </a:xfrm>
        </p:grpSpPr>
        <p:sp>
          <p:nvSpPr>
            <p:cNvPr id="154" name="TextBox 153"/>
            <p:cNvSpPr txBox="1"/>
            <p:nvPr/>
          </p:nvSpPr>
          <p:spPr>
            <a:xfrm>
              <a:off x="4367548" y="1175528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sB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155" name="Straight Arrow Connector 154"/>
            <p:cNvCxnSpPr/>
            <p:nvPr/>
          </p:nvCxnSpPr>
          <p:spPr>
            <a:xfrm flipH="1">
              <a:off x="4320533" y="1301404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</p:grpSp>
      <p:sp>
        <p:nvSpPr>
          <p:cNvPr id="157" name="TextBox 156"/>
          <p:cNvSpPr txBox="1"/>
          <p:nvPr/>
        </p:nvSpPr>
        <p:spPr>
          <a:xfrm rot="18000000">
            <a:off x="1162630" y="3677904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 rot="18000000">
            <a:off x="1488823" y="356243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 rot="18000000">
            <a:off x="1829489" y="355346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 rot="18000000">
            <a:off x="1972450" y="3537767"/>
            <a:ext cx="6238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 rot="18000000">
            <a:off x="2217222" y="355121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C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 rot="18000000">
            <a:off x="2319129" y="3508623"/>
            <a:ext cx="7328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ssC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+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3" name="Group 162"/>
          <p:cNvGrpSpPr/>
          <p:nvPr/>
        </p:nvGrpSpPr>
        <p:grpSpPr>
          <a:xfrm>
            <a:off x="2744315" y="4049170"/>
            <a:ext cx="540671" cy="230832"/>
            <a:chOff x="4320533" y="1175528"/>
            <a:chExt cx="540671" cy="230832"/>
          </a:xfrm>
        </p:grpSpPr>
        <p:sp>
          <p:nvSpPr>
            <p:cNvPr id="164" name="TextBox 163"/>
            <p:cNvSpPr txBox="1"/>
            <p:nvPr/>
          </p:nvSpPr>
          <p:spPr>
            <a:xfrm>
              <a:off x="4367548" y="1175528"/>
              <a:ext cx="493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solidFill>
                    <a:prstClr val="black"/>
                  </a:solidFill>
                  <a:latin typeface="Arial"/>
                </a:rPr>
                <a:t>EssC</a:t>
              </a:r>
              <a:endParaRPr lang="en-GB" sz="900" dirty="0">
                <a:solidFill>
                  <a:prstClr val="black"/>
                </a:solidFill>
                <a:latin typeface="Arial"/>
              </a:endParaRPr>
            </a:p>
          </p:txBody>
        </p:sp>
        <p:cxnSp>
          <p:nvCxnSpPr>
            <p:cNvPr id="165" name="Straight Arrow Connector 164"/>
            <p:cNvCxnSpPr/>
            <p:nvPr/>
          </p:nvCxnSpPr>
          <p:spPr>
            <a:xfrm flipH="1">
              <a:off x="4320533" y="1301404"/>
              <a:ext cx="120257" cy="0"/>
            </a:xfrm>
            <a:prstGeom prst="straightConnector1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tailEnd type="triangle"/>
            </a:ln>
            <a:effectLst/>
          </p:spPr>
        </p:cxnSp>
      </p:grpSp>
      <p:sp>
        <p:nvSpPr>
          <p:cNvPr id="166" name="TextBox 165"/>
          <p:cNvSpPr txBox="1"/>
          <p:nvPr/>
        </p:nvSpPr>
        <p:spPr>
          <a:xfrm>
            <a:off x="0" y="8683228"/>
            <a:ext cx="205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>
                <a:solidFill>
                  <a:prstClr val="black"/>
                </a:solidFill>
                <a:latin typeface="Arial"/>
              </a:rPr>
              <a:t>Jäger</a:t>
            </a:r>
            <a:r>
              <a:rPr lang="en-GB" dirty="0" smtClean="0">
                <a:solidFill>
                  <a:prstClr val="black"/>
                </a:solidFill>
                <a:latin typeface="Arial"/>
              </a:rPr>
              <a:t> </a:t>
            </a:r>
            <a:r>
              <a:rPr lang="en-GB" i="1" dirty="0" smtClean="0">
                <a:solidFill>
                  <a:prstClr val="black"/>
                </a:solidFill>
                <a:latin typeface="Arial"/>
              </a:rPr>
              <a:t>et al</a:t>
            </a:r>
            <a:r>
              <a:rPr lang="en-GB" dirty="0" smtClean="0">
                <a:solidFill>
                  <a:prstClr val="black"/>
                </a:solidFill>
                <a:latin typeface="Arial"/>
              </a:rPr>
              <a:t>. </a:t>
            </a:r>
            <a:r>
              <a:rPr lang="en-GB" dirty="0" smtClean="0">
                <a:solidFill>
                  <a:prstClr val="black"/>
                </a:solidFill>
                <a:latin typeface="Arial"/>
              </a:rPr>
              <a:t>Fig S2</a:t>
            </a:r>
            <a:endParaRPr lang="en-GB" dirty="0">
              <a:solidFill>
                <a:prstClr val="black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32211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46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Dunde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sting diff. detergents with RN6390 WT</dc:title>
  <dc:creator>Franziska Jaeger</dc:creator>
  <cp:lastModifiedBy>Tracy Palmer</cp:lastModifiedBy>
  <cp:revision>7</cp:revision>
  <cp:lastPrinted>2015-09-28T13:18:21Z</cp:lastPrinted>
  <dcterms:created xsi:type="dcterms:W3CDTF">2015-09-18T08:52:44Z</dcterms:created>
  <dcterms:modified xsi:type="dcterms:W3CDTF">2015-09-28T14:13:53Z</dcterms:modified>
</cp:coreProperties>
</file>